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6"/>
  </p:notesMasterIdLst>
  <p:sldIdLst>
    <p:sldId id="256" r:id="rId2"/>
    <p:sldId id="259" r:id="rId3"/>
    <p:sldId id="257" r:id="rId4"/>
    <p:sldId id="258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1" d="100"/>
          <a:sy n="51" d="100"/>
        </p:scale>
        <p:origin x="6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6ECFF5-4186-438F-A9BC-00680600D73E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98F74B-DA6A-4B11-96F4-6D04EA6003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2520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1pPr>
    <a:lvl2pPr marL="286527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2pPr>
    <a:lvl3pPr marL="573054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3pPr>
    <a:lvl4pPr marL="859582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4pPr>
    <a:lvl5pPr marL="1146109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5pPr>
    <a:lvl6pPr marL="1432636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6pPr>
    <a:lvl7pPr marL="1719163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7pPr>
    <a:lvl8pPr marL="2005691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8pPr>
    <a:lvl9pPr marL="2292218" algn="l" defTabSz="573054" rtl="0" eaLnBrk="1" latinLnBrk="0" hangingPunct="1">
      <a:defRPr sz="75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972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25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345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965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83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693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590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917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560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020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991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D4DD2-9345-47DA-A1BB-C4D9820FA607}" type="datetimeFigureOut">
              <a:rPr lang="en-US" smtClean="0"/>
              <a:t>3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729C7-3CA6-4F38-B15E-2E3AB0BCF1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559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="" xmlns:a16="http://schemas.microsoft.com/office/drawing/2014/main" id="{E3FD5D58-758E-4F98-88BF-0605A0148B0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8" r="23614"/>
          <a:stretch/>
        </p:blipFill>
        <p:spPr>
          <a:xfrm>
            <a:off x="4452277" y="2507517"/>
            <a:ext cx="3321161" cy="354599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="" xmlns:a16="http://schemas.microsoft.com/office/drawing/2014/main" id="{63FF3D94-B0E3-45A9-9669-C372BA04C7E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4"/>
          <a:stretch/>
        </p:blipFill>
        <p:spPr>
          <a:xfrm>
            <a:off x="4478418" y="-3"/>
            <a:ext cx="3293982" cy="250751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="" xmlns:a16="http://schemas.microsoft.com/office/drawing/2014/main" id="{434764BE-9946-43A0-AB13-F6FA3008612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63" t="1" r="24856" b="29967"/>
          <a:stretch/>
        </p:blipFill>
        <p:spPr>
          <a:xfrm>
            <a:off x="-1" y="2507519"/>
            <a:ext cx="4478419" cy="3545999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="" xmlns:a16="http://schemas.microsoft.com/office/drawing/2014/main" id="{DEA36F94-3538-42EB-B8B5-3A0A9D870A5A}"/>
              </a:ext>
            </a:extLst>
          </p:cNvPr>
          <p:cNvSpPr/>
          <p:nvPr/>
        </p:nvSpPr>
        <p:spPr>
          <a:xfrm>
            <a:off x="8879041" y="5052493"/>
            <a:ext cx="436880" cy="8686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17" name="Picture 16">
            <a:extLst>
              <a:ext uri="{FF2B5EF4-FFF2-40B4-BE49-F238E27FC236}">
                <a16:creationId xmlns="" xmlns:a16="http://schemas.microsoft.com/office/drawing/2014/main" id="{83988806-1352-48B2-BCA5-B4A0C6B0CEF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615" r="-591"/>
          <a:stretch/>
        </p:blipFill>
        <p:spPr>
          <a:xfrm>
            <a:off x="0" y="-1"/>
            <a:ext cx="4504559" cy="2522157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33A7E507-F0A3-455B-A5D0-9CB84ED7EC10}"/>
              </a:ext>
            </a:extLst>
          </p:cNvPr>
          <p:cNvSpPr txBox="1"/>
          <p:nvPr/>
        </p:nvSpPr>
        <p:spPr>
          <a:xfrm>
            <a:off x="228600" y="6553200"/>
            <a:ext cx="710565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dentifying features (Coetzee 2020) of an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bbinsi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 that was molecularly confirmed as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. species 6 </a:t>
            </a:r>
          </a:p>
          <a:p>
            <a:pPr algn="l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A: the entire specimen</a:t>
            </a:r>
          </a:p>
          <a:p>
            <a:pPr algn="l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B: Palps with three white bands</a:t>
            </a:r>
          </a:p>
          <a:p>
            <a:pPr algn="l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C: </a:t>
            </a:r>
            <a:r>
              <a:rPr lang="en-US" sz="14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g with pale interruption in 3rd main dark area of vein 1, and upper branch of wing vein 5 with 2 well-developed pale spots, Wing vein 3 largely dark or broadly dark at either end Panel D: </a:t>
            </a:r>
            <a:r>
              <a:rPr lang="en-US" sz="1400" b="0" i="0" u="none" strike="noStrike" baseline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ndtarsomeres</a:t>
            </a:r>
            <a:r>
              <a:rPr lang="en-US" sz="14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to 4 with narrow pale bands, as long or shorter</a:t>
            </a:r>
          </a:p>
          <a:p>
            <a:pPr algn="l"/>
            <a:r>
              <a:rPr lang="en-US" sz="1400" b="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an the width of the tarsomere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10532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7184793"/>
              </p:ext>
            </p:extLst>
          </p:nvPr>
        </p:nvGraphicFramePr>
        <p:xfrm>
          <a:off x="0" y="4076700"/>
          <a:ext cx="7708744" cy="201145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47700"/>
                <a:gridCol w="638175"/>
                <a:gridCol w="571423"/>
                <a:gridCol w="904952"/>
                <a:gridCol w="2628822"/>
                <a:gridCol w="2317672"/>
              </a:tblGrid>
              <a:tr h="119816">
                <a:tc gridSpan="6"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 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ble 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 Primers</a:t>
                      </a:r>
                      <a:r>
                        <a:rPr lang="en-US" sz="1200" baseline="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cluded in Host DNA PCR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51396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st DN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duct length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sourc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 (5' - 3'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 (5' - 3'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</a:tr>
              <a:tr h="21696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a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-loop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umar et al.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TTCAGGGCCATCTCATC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GATGCATGGTGAAAT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</a:tr>
              <a:tr h="21696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icken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I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zadpanah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t al.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TGTCATGAAGGGCAATA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TCCTTACCCGTCCTAGC</a:t>
                      </a:r>
                      <a:endParaRPr lang="en-US" sz="11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</a:tr>
              <a:tr h="21696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w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I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ATTCCAACCGGGGTAAAAGTC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AATAAAGCCTAGGGCTCAC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</a:tr>
              <a:tr h="21696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an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nt et al.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TTACTTCTCTTCATTCTCTCCT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TGTCCTCCAATTCATGTTA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</a:tr>
              <a:tr h="21696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ATTGTACTATTATTCGCAACCAT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16963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g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B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CGCAGCCGTACATCTC</a:t>
                      </a:r>
                      <a:endParaRPr lang="en-U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7430" marR="6743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034469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="" xmlns:a16="http://schemas.microsoft.com/office/drawing/2014/main" id="{6818D65D-31F3-4702-A5D9-4B9B34D108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7136819"/>
              </p:ext>
            </p:extLst>
          </p:nvPr>
        </p:nvGraphicFramePr>
        <p:xfrm>
          <a:off x="0" y="2162175"/>
          <a:ext cx="7733949" cy="6205995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706185">
                  <a:extLst>
                    <a:ext uri="{9D8B030D-6E8A-4147-A177-3AD203B41FA5}">
                      <a16:colId xmlns="" xmlns:a16="http://schemas.microsoft.com/office/drawing/2014/main" val="733128776"/>
                    </a:ext>
                  </a:extLst>
                </a:gridCol>
                <a:gridCol w="738026">
                  <a:extLst>
                    <a:ext uri="{9D8B030D-6E8A-4147-A177-3AD203B41FA5}">
                      <a16:colId xmlns="" xmlns:a16="http://schemas.microsoft.com/office/drawing/2014/main" val="2376080269"/>
                    </a:ext>
                  </a:extLst>
                </a:gridCol>
                <a:gridCol w="691198">
                  <a:extLst>
                    <a:ext uri="{9D8B030D-6E8A-4147-A177-3AD203B41FA5}">
                      <a16:colId xmlns="" xmlns:a16="http://schemas.microsoft.com/office/drawing/2014/main" val="813800679"/>
                    </a:ext>
                  </a:extLst>
                </a:gridCol>
                <a:gridCol w="811091"/>
                <a:gridCol w="594505">
                  <a:extLst>
                    <a:ext uri="{9D8B030D-6E8A-4147-A177-3AD203B41FA5}">
                      <a16:colId xmlns="" xmlns:a16="http://schemas.microsoft.com/office/drawing/2014/main" val="978639773"/>
                    </a:ext>
                  </a:extLst>
                </a:gridCol>
                <a:gridCol w="732391">
                  <a:extLst>
                    <a:ext uri="{9D8B030D-6E8A-4147-A177-3AD203B41FA5}">
                      <a16:colId xmlns="" xmlns:a16="http://schemas.microsoft.com/office/drawing/2014/main" val="3801420671"/>
                    </a:ext>
                  </a:extLst>
                </a:gridCol>
                <a:gridCol w="573212">
                  <a:extLst>
                    <a:ext uri="{9D8B030D-6E8A-4147-A177-3AD203B41FA5}">
                      <a16:colId xmlns="" xmlns:a16="http://schemas.microsoft.com/office/drawing/2014/main" val="4061473845"/>
                    </a:ext>
                  </a:extLst>
                </a:gridCol>
                <a:gridCol w="715493">
                  <a:extLst>
                    <a:ext uri="{9D8B030D-6E8A-4147-A177-3AD203B41FA5}">
                      <a16:colId xmlns="" xmlns:a16="http://schemas.microsoft.com/office/drawing/2014/main" val="3011931116"/>
                    </a:ext>
                  </a:extLst>
                </a:gridCol>
                <a:gridCol w="613346"/>
                <a:gridCol w="633456"/>
                <a:gridCol w="925046">
                  <a:extLst>
                    <a:ext uri="{9D8B030D-6E8A-4147-A177-3AD203B41FA5}">
                      <a16:colId xmlns="" xmlns:a16="http://schemas.microsoft.com/office/drawing/2014/main" val="2509295879"/>
                    </a:ext>
                  </a:extLst>
                </a:gridCol>
              </a:tblGrid>
              <a:tr h="52166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 ID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rphology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H number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ap location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lection Date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S2 Accession Number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S2 </a:t>
                      </a: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S2 BLAST result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I fragment *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I accession number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I BLAST result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039196224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N594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specimen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  <a:endParaRPr lang="en-US" sz="800" i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8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82605099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N615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specimen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6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8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378326167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N616</a:t>
                      </a:r>
                      <a:endParaRPr lang="en-US" sz="8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specimen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6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8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17388416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N61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i="1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grid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specimen sent to Wit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6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N61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i="1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gridSpan="3">
                  <a:txBody>
                    <a:bodyPr/>
                    <a:lstStyle/>
                    <a:p>
                      <a:pPr marL="0" marR="0" lvl="0" indent="0" algn="ctr" defTabSz="77724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specimen sent to Wits</a:t>
                      </a: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6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N61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i="1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gridSpan="3">
                  <a:txBody>
                    <a:bodyPr/>
                    <a:lstStyle/>
                    <a:p>
                      <a:pPr marL="0" marR="0" lvl="0" indent="0" algn="ctr" defTabSz="77724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specimen sent to Wits</a:t>
                      </a: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6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GNcN779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i="1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gridSpan="3">
                  <a:txBody>
                    <a:bodyPr/>
                    <a:lstStyle/>
                    <a:p>
                      <a:pPr marL="0" marR="0" lvl="0" indent="0" algn="ctr" defTabSz="77724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specimen sent to Wits</a:t>
                      </a: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6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11</a:t>
                      </a:r>
                      <a:r>
                        <a:rPr lang="en-US" sz="800" b="0" i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†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N86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i="1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gridSpan="3">
                  <a:txBody>
                    <a:bodyPr/>
                    <a:lstStyle/>
                    <a:p>
                      <a:pPr marL="0" marR="0" lvl="0" indent="0" algn="ctr" defTabSz="77724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 specimen sent to Wits</a:t>
                      </a: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- </a:t>
                      </a: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04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door gatheri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3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553999290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1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o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3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039087613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2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</a:t>
                      </a:r>
                      <a:r>
                        <a:rPr lang="en-US" sz="800" b="0" i="1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800" b="0" i="1" u="none" strike="noStrike" baseline="0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-Jul-1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2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o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361481191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38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door gatheri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965309566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48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pe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208320074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4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pe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01816151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59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o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-Jul-2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72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pe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307374993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7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pe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8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45689578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8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o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822244499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098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door gatheri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348918129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10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pe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-Jul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3743471913"/>
                  </a:ext>
                </a:extLst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129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door gatheri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-Aug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139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door gatheri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-Aug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14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door gatheri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-Aug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14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o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-Aug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22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or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-Aug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23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pe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-Aug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24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door gathering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-Aug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7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268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imal pen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-Aug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8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276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door gatherin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-Aug-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8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276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door gatherin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-Aug-1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5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80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165406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GNc321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</a:t>
                      </a:r>
                      <a:r>
                        <a:rPr lang="en-US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ins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door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-Aug-19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9760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i="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58</a:t>
                      </a: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M456803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i="1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. species 6</a:t>
                      </a:r>
                      <a:endParaRPr lang="en-US" sz="8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5406">
                <a:tc gridSpan="1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Note this fragment length was determined in </a:t>
                      </a:r>
                      <a:r>
                        <a:rPr lang="en-US" sz="8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ious</a:t>
                      </a: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fter trimming primer </a:t>
                      </a:r>
                      <a:r>
                        <a:rPr lang="en-US" sz="8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s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†This sequence had low quality ends and was trimmed </a:t>
                      </a:r>
                      <a:r>
                        <a:rPr lang="en-US" sz="800" b="0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efore the beginning of primer sequences on both 5’ and 3’ ends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i="0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its = University of </a:t>
                      </a:r>
                      <a:r>
                        <a:rPr lang="en-US" sz="800" b="0" i="0" kern="1200" baseline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itswatersrand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alpha val="2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901324183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5925936F-DA1B-4BE9-ACCA-D17987F0D95A}"/>
              </a:ext>
            </a:extLst>
          </p:cNvPr>
          <p:cNvSpPr txBox="1"/>
          <p:nvPr/>
        </p:nvSpPr>
        <p:spPr>
          <a:xfrm>
            <a:off x="190498" y="1762125"/>
            <a:ext cx="6595983" cy="3692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2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d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bbinsi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</a:p>
        </p:txBody>
      </p:sp>
    </p:spTree>
    <p:extLst>
      <p:ext uri="{BB962C8B-B14F-4D97-AF65-F5344CB8AC3E}">
        <p14:creationId xmlns:p14="http://schemas.microsoft.com/office/powerpoint/2010/main" val="17410031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7533782"/>
              </p:ext>
            </p:extLst>
          </p:nvPr>
        </p:nvGraphicFramePr>
        <p:xfrm>
          <a:off x="534354" y="3002598"/>
          <a:ext cx="6442346" cy="1520190"/>
        </p:xfrm>
        <a:graphic>
          <a:graphicData uri="http://schemas.openxmlformats.org/drawingml/2006/table">
            <a:tbl>
              <a:tblPr firstRow="1" lastRow="1" bandRow="1">
                <a:tableStyleId>{9D7B26C5-4107-4FEC-AEDC-1716B250A1EF}</a:tableStyleId>
              </a:tblPr>
              <a:tblGrid>
                <a:gridCol w="128587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3046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8150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81503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081503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08150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141619">
                <a:tc gridSpan="6">
                  <a:txBody>
                    <a:bodyPr/>
                    <a:lstStyle/>
                    <a:p>
                      <a:pPr algn="l" fontAlgn="ctr"/>
                      <a:r>
                        <a:rPr lang="en-US" sz="1600" b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pplementary table 3. Host DNA detection by visually blooded status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</a:tr>
              <a:tr h="141619"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sually blooded status</a:t>
                      </a:r>
                      <a:endParaRPr lang="en-US" sz="1600" u="none" strike="noStrike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st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</a:tr>
              <a:tr h="252141">
                <a:tc vMerge="1">
                  <a:txBody>
                    <a:bodyPr/>
                    <a:lstStyle/>
                    <a:p>
                      <a:pPr algn="l" fontAlgn="ctr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at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uman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g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161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t blooded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3139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ooded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 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344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61318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6</TotalTime>
  <Words>913</Words>
  <Application>Microsoft Office PowerPoint</Application>
  <PresentationFormat>Custom</PresentationFormat>
  <Paragraphs>42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 Gebhardt</dc:creator>
  <cp:lastModifiedBy>Mary Gebhardt</cp:lastModifiedBy>
  <cp:revision>24</cp:revision>
  <dcterms:created xsi:type="dcterms:W3CDTF">2021-11-04T17:34:20Z</dcterms:created>
  <dcterms:modified xsi:type="dcterms:W3CDTF">2022-03-20T14:40:32Z</dcterms:modified>
</cp:coreProperties>
</file>